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94" r:id="rId2"/>
    <p:sldId id="283" r:id="rId3"/>
    <p:sldId id="286" r:id="rId4"/>
    <p:sldId id="298" r:id="rId5"/>
    <p:sldId id="299" r:id="rId6"/>
    <p:sldId id="300" r:id="rId7"/>
    <p:sldId id="301" r:id="rId8"/>
    <p:sldId id="293" r:id="rId9"/>
    <p:sldId id="318" r:id="rId10"/>
    <p:sldId id="311" r:id="rId11"/>
    <p:sldId id="313" r:id="rId12"/>
    <p:sldId id="314" r:id="rId13"/>
    <p:sldId id="315" r:id="rId14"/>
    <p:sldId id="307" r:id="rId15"/>
    <p:sldId id="316" r:id="rId16"/>
    <p:sldId id="317" r:id="rId17"/>
    <p:sldId id="306" r:id="rId18"/>
    <p:sldId id="309" r:id="rId19"/>
    <p:sldId id="308" r:id="rId20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ew user" initials="nu" lastIdx="1" clrIdx="0">
    <p:extLst>
      <p:ext uri="{19B8F6BF-5375-455C-9EA6-DF929625EA0E}">
        <p15:presenceInfo xmlns:p15="http://schemas.microsoft.com/office/powerpoint/2012/main" userId="new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158" autoAdjust="0"/>
    <p:restoredTop sz="94660"/>
  </p:normalViewPr>
  <p:slideViewPr>
    <p:cSldViewPr snapToGrid="0">
      <p:cViewPr varScale="1">
        <p:scale>
          <a:sx n="48" d="100"/>
          <a:sy n="48" d="100"/>
        </p:scale>
        <p:origin x="246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315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microsoft.com/office/2016/11/relationships/changesInfo" Target="changesInfos/changesInfo1.xml"/><Relationship Id="rId3" Type="http://schemas.openxmlformats.org/officeDocument/2006/relationships/slide" Target="slides/slide2.xml"/><Relationship Id="rId21" Type="http://schemas.openxmlformats.org/officeDocument/2006/relationships/commentAuthors" Target="comment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harika Duggal (Inflammation and Ageing)" userId="9f20a8dc-e72c-4388-87fe-ebb18a82332b" providerId="ADAL" clId="{C73FA720-5AE3-4493-8A86-686B172AAA30}"/>
    <pc:docChg chg="custSel modSld">
      <pc:chgData name="Niharika Duggal (Inflammation and Ageing)" userId="9f20a8dc-e72c-4388-87fe-ebb18a82332b" providerId="ADAL" clId="{C73FA720-5AE3-4493-8A86-686B172AAA30}" dt="2025-07-10T19:19:03.458" v="295" actId="478"/>
      <pc:docMkLst>
        <pc:docMk/>
      </pc:docMkLst>
      <pc:sldChg chg="modSp mod">
        <pc:chgData name="Niharika Duggal (Inflammation and Ageing)" userId="9f20a8dc-e72c-4388-87fe-ebb18a82332b" providerId="ADAL" clId="{C73FA720-5AE3-4493-8A86-686B172AAA30}" dt="2025-07-10T19:15:55.409" v="272" actId="20577"/>
        <pc:sldMkLst>
          <pc:docMk/>
          <pc:sldMk cId="1780775186" sldId="283"/>
        </pc:sldMkLst>
        <pc:graphicFrameChg chg="modGraphic">
          <ac:chgData name="Niharika Duggal (Inflammation and Ageing)" userId="9f20a8dc-e72c-4388-87fe-ebb18a82332b" providerId="ADAL" clId="{C73FA720-5AE3-4493-8A86-686B172AAA30}" dt="2025-07-10T19:15:55.409" v="272" actId="20577"/>
          <ac:graphicFrameMkLst>
            <pc:docMk/>
            <pc:sldMk cId="1780775186" sldId="283"/>
            <ac:graphicFrameMk id="2" creationId="{4B1B6068-4F87-4EBF-8165-A9795C2188ED}"/>
          </ac:graphicFrameMkLst>
        </pc:graphicFrameChg>
      </pc:sldChg>
      <pc:sldChg chg="addSp delSp modSp mod">
        <pc:chgData name="Niharika Duggal (Inflammation and Ageing)" userId="9f20a8dc-e72c-4388-87fe-ebb18a82332b" providerId="ADAL" clId="{C73FA720-5AE3-4493-8A86-686B172AAA30}" dt="2025-07-10T19:19:03.458" v="295" actId="478"/>
        <pc:sldMkLst>
          <pc:docMk/>
          <pc:sldMk cId="1371079673" sldId="299"/>
        </pc:sldMkLst>
        <pc:graphicFrameChg chg="add del modGraphic">
          <ac:chgData name="Niharika Duggal (Inflammation and Ageing)" userId="9f20a8dc-e72c-4388-87fe-ebb18a82332b" providerId="ADAL" clId="{C73FA720-5AE3-4493-8A86-686B172AAA30}" dt="2025-07-10T19:19:03.458" v="295" actId="478"/>
          <ac:graphicFrameMkLst>
            <pc:docMk/>
            <pc:sldMk cId="1371079673" sldId="299"/>
            <ac:graphicFrameMk id="5" creationId="{300154D4-B59B-7103-88C8-A49E7A8A2B48}"/>
          </ac:graphicFrameMkLst>
        </pc:graphicFrameChg>
      </pc:sldChg>
      <pc:sldChg chg="modSp mod">
        <pc:chgData name="Niharika Duggal (Inflammation and Ageing)" userId="9f20a8dc-e72c-4388-87fe-ebb18a82332b" providerId="ADAL" clId="{C73FA720-5AE3-4493-8A86-686B172AAA30}" dt="2025-07-10T19:16:47.806" v="293" actId="20577"/>
        <pc:sldMkLst>
          <pc:docMk/>
          <pc:sldMk cId="2650571114" sldId="318"/>
        </pc:sldMkLst>
        <pc:spChg chg="mod">
          <ac:chgData name="Niharika Duggal (Inflammation and Ageing)" userId="9f20a8dc-e72c-4388-87fe-ebb18a82332b" providerId="ADAL" clId="{C73FA720-5AE3-4493-8A86-686B172AAA30}" dt="2025-07-10T19:16:47.806" v="293" actId="20577"/>
          <ac:spMkLst>
            <pc:docMk/>
            <pc:sldMk cId="2650571114" sldId="318"/>
            <ac:spMk id="3" creationId="{AF42E868-DC96-4276-BE89-F353E2C311C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8839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0923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108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6045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5230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1464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8688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0005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0532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193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386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A5BFB-B091-49EA-87D1-60E89C26FD2A}" type="datetimeFigureOut">
              <a:rPr lang="en-GB" smtClean="0"/>
              <a:t>01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220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B5143314-A49C-4295-AA78-9C1B18C16931}"/>
              </a:ext>
            </a:extLst>
          </p:cNvPr>
          <p:cNvCxnSpPr>
            <a:cxnSpLocks/>
          </p:cNvCxnSpPr>
          <p:nvPr/>
        </p:nvCxnSpPr>
        <p:spPr>
          <a:xfrm>
            <a:off x="3772170" y="523464"/>
            <a:ext cx="100272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AB758EA1-9DA3-4D05-B767-3C2DC58A5685}"/>
              </a:ext>
            </a:extLst>
          </p:cNvPr>
          <p:cNvCxnSpPr>
            <a:cxnSpLocks/>
          </p:cNvCxnSpPr>
          <p:nvPr/>
        </p:nvCxnSpPr>
        <p:spPr>
          <a:xfrm flipV="1">
            <a:off x="3772170" y="571573"/>
            <a:ext cx="724537" cy="8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A3B12F42-8D71-4EF2-8CA9-E493CFA259A6}"/>
              </a:ext>
            </a:extLst>
          </p:cNvPr>
          <p:cNvSpPr txBox="1"/>
          <p:nvPr/>
        </p:nvSpPr>
        <p:spPr>
          <a:xfrm>
            <a:off x="3684965" y="2219824"/>
            <a:ext cx="2053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049115-8C1F-4108-90AB-48C43D8D01D2}"/>
              </a:ext>
            </a:extLst>
          </p:cNvPr>
          <p:cNvSpPr txBox="1"/>
          <p:nvPr/>
        </p:nvSpPr>
        <p:spPr>
          <a:xfrm>
            <a:off x="4849014" y="198095"/>
            <a:ext cx="2053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12C69F-FEC6-4F5F-8649-6985024D0848}"/>
              </a:ext>
            </a:extLst>
          </p:cNvPr>
          <p:cNvSpPr txBox="1"/>
          <p:nvPr/>
        </p:nvSpPr>
        <p:spPr>
          <a:xfrm>
            <a:off x="248168" y="4212691"/>
            <a:ext cx="6478096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. CD8 T cell subset distribution across disease phases leading up to the development of Rheumatoid Arthriti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GB" sz="1100" b="1" dirty="0"/>
              <a:t> </a:t>
            </a:r>
            <a:endParaRPr lang="en-GB" sz="1200" b="1" dirty="0"/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7F072AA-3EA5-4F99-952A-B79312227BE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29225" y="869976"/>
          <a:ext cx="3264453" cy="28836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5353920" imgH="3157560" progId="Prism5.Document">
                  <p:embed/>
                </p:oleObj>
              </mc:Choice>
              <mc:Fallback>
                <p:oleObj name="Prism 5" r:id="rId2" imgW="5353920" imgH="3157560" progId="Prism5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77F072AA-3EA5-4F99-952A-B79312227B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9225" y="869976"/>
                        <a:ext cx="3264453" cy="28836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0DC7A247-3736-4FEE-BBDA-20CBCD9AE7AC}"/>
              </a:ext>
            </a:extLst>
          </p:cNvPr>
          <p:cNvSpPr txBox="1"/>
          <p:nvPr/>
        </p:nvSpPr>
        <p:spPr>
          <a:xfrm>
            <a:off x="233343" y="483461"/>
            <a:ext cx="2053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A</a:t>
            </a:r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FC3DCC3-9C5A-49A6-9E5E-8C89954B89A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00399" y="414174"/>
          <a:ext cx="1779477" cy="17650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791412" imgH="2993432" progId="Prism9.Document">
                  <p:embed/>
                </p:oleObj>
              </mc:Choice>
              <mc:Fallback>
                <p:oleObj name="Prism 9" r:id="rId4" imgW="2791412" imgH="2993432" progId="Prism9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7FC3DCC3-9C5A-49A6-9E5E-8C89954B89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00399" y="414174"/>
                        <a:ext cx="1779477" cy="17650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EC276DCF-6C67-4574-B8EA-C6CF84CEC493}"/>
              </a:ext>
            </a:extLst>
          </p:cNvPr>
          <p:cNvSpPr txBox="1"/>
          <p:nvPr/>
        </p:nvSpPr>
        <p:spPr>
          <a:xfrm>
            <a:off x="3265956" y="239196"/>
            <a:ext cx="2053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B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A725A37D-42B1-4FE0-9867-7FAAE1F1B8E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74896" y="373544"/>
          <a:ext cx="2019639" cy="18634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921061" imgH="3068322" progId="Prism9.Document">
                  <p:embed/>
                </p:oleObj>
              </mc:Choice>
              <mc:Fallback>
                <p:oleObj name="Prism 9" r:id="rId6" imgW="2921061" imgH="3068322" progId="Prism9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A725A37D-42B1-4FE0-9867-7FAAE1F1B8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74896" y="373544"/>
                        <a:ext cx="2019639" cy="18634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18784C3-5DB1-49D6-A831-916E49B403C1}"/>
              </a:ext>
            </a:extLst>
          </p:cNvPr>
          <p:cNvCxnSpPr>
            <a:cxnSpLocks/>
          </p:cNvCxnSpPr>
          <p:nvPr/>
        </p:nvCxnSpPr>
        <p:spPr>
          <a:xfrm>
            <a:off x="4349433" y="2483728"/>
            <a:ext cx="100272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2E4735E4-D167-405A-ACF3-C4B2B6223E9F}"/>
              </a:ext>
            </a:extLst>
          </p:cNvPr>
          <p:cNvCxnSpPr>
            <a:cxnSpLocks/>
          </p:cNvCxnSpPr>
          <p:nvPr/>
        </p:nvCxnSpPr>
        <p:spPr>
          <a:xfrm flipV="1">
            <a:off x="4349433" y="2531837"/>
            <a:ext cx="724537" cy="8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360C07F-472F-41B4-BCA4-681D246AD9E7}"/>
              </a:ext>
            </a:extLst>
          </p:cNvPr>
          <p:cNvCxnSpPr>
            <a:cxnSpLocks/>
          </p:cNvCxnSpPr>
          <p:nvPr/>
        </p:nvCxnSpPr>
        <p:spPr>
          <a:xfrm>
            <a:off x="4358639" y="2591861"/>
            <a:ext cx="49037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DA320719-D1C6-40B0-B273-B43A52AB9BB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03013" y="2364897"/>
          <a:ext cx="1970950" cy="17492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921061" imgH="3068322" progId="Prism9.Document">
                  <p:embed/>
                </p:oleObj>
              </mc:Choice>
              <mc:Fallback>
                <p:oleObj name="Prism 9" r:id="rId8" imgW="2921061" imgH="3068322" progId="Prism9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DA320719-D1C6-40B0-B273-B43A52AB9B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803013" y="2364897"/>
                        <a:ext cx="1970950" cy="17492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C2BEC622-B2CD-4C71-A4B0-713C59BFA302}"/>
              </a:ext>
            </a:extLst>
          </p:cNvPr>
          <p:cNvSpPr txBox="1"/>
          <p:nvPr/>
        </p:nvSpPr>
        <p:spPr>
          <a:xfrm>
            <a:off x="4024869" y="312102"/>
            <a:ext cx="9939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/>
              <a:t>P = 0.00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68738D7-0F78-457C-9546-005702CACFDD}"/>
              </a:ext>
            </a:extLst>
          </p:cNvPr>
          <p:cNvSpPr txBox="1"/>
          <p:nvPr/>
        </p:nvSpPr>
        <p:spPr>
          <a:xfrm>
            <a:off x="4563649" y="2288484"/>
            <a:ext cx="9939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/>
              <a:t>P = 0.00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7915D1F-338A-4A99-ADFF-CA039930439E}"/>
              </a:ext>
            </a:extLst>
          </p:cNvPr>
          <p:cNvSpPr txBox="1"/>
          <p:nvPr/>
        </p:nvSpPr>
        <p:spPr>
          <a:xfrm rot="16200000">
            <a:off x="-881776" y="1666890"/>
            <a:ext cx="25368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Cell frequencies (% CD8 T cells )</a:t>
            </a:r>
          </a:p>
        </p:txBody>
      </p:sp>
    </p:spTree>
    <p:extLst>
      <p:ext uri="{BB962C8B-B14F-4D97-AF65-F5344CB8AC3E}">
        <p14:creationId xmlns:p14="http://schemas.microsoft.com/office/powerpoint/2010/main" val="292593002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BD4C4D2-7E25-44AE-9FC1-E9902BE354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2449952"/>
              </p:ext>
            </p:extLst>
          </p:nvPr>
        </p:nvGraphicFramePr>
        <p:xfrm>
          <a:off x="676895" y="580434"/>
          <a:ext cx="5631309" cy="603365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4422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951104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971721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901354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  <a:gridCol w="1061927">
                  <a:extLst>
                    <a:ext uri="{9D8B030D-6E8A-4147-A177-3AD203B41FA5}">
                      <a16:colId xmlns:a16="http://schemas.microsoft.com/office/drawing/2014/main" val="1087484425"/>
                    </a:ext>
                  </a:extLst>
                </a:gridCol>
                <a:gridCol w="740781">
                  <a:extLst>
                    <a:ext uri="{9D8B030D-6E8A-4147-A177-3AD203B41FA5}">
                      <a16:colId xmlns:a16="http://schemas.microsoft.com/office/drawing/2014/main" val="2756801190"/>
                    </a:ext>
                  </a:extLst>
                </a:gridCol>
              </a:tblGrid>
              <a:tr h="390739"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Genes</a:t>
                      </a: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Mean Gene expression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3228766"/>
                  </a:ext>
                </a:extLst>
              </a:tr>
              <a:tr h="390739">
                <a:tc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Healthy Contro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Arthralg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CARD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95.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1.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.97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2.48, 3.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4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CD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729.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31.4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69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41, 2.0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5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32381871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CD9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178.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347.8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62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36, 1.9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5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47412011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CDKN1A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16.5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25.1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.9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64, 2.3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3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06008119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CFP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013.2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25.5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.53</a:t>
                      </a:r>
                      <a:endParaRPr lang="en-GB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28, 1.8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4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247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CLEC6A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3.7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1.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.03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70, 2.4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4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2806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CYLD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023.9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06.2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27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06, 1.5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1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FCER1G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764.2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165.3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51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25, 1.8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4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FLT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8.7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8.0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.09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75, 2.5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2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GPI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79.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54.1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35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13, 1.6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2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28523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HLA-A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998.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73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19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00, 1.42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5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HLA-DRB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237.2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91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59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33,1.90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3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24552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ICO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11.7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84.1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6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38, 1.97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1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2927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IL12RB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2.6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93.7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.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76, 3.4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2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IRF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5.9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4.7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.37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98, 2.8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5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22758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LAMP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70.5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947.1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.13</a:t>
                      </a:r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0.95, 1.35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5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  <a:tr h="22758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err="1">
                          <a:effectLst/>
                        </a:rPr>
                        <a:t>KIR_Activating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.35</a:t>
                      </a:r>
                      <a:endParaRPr lang="en-GB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97, 2.81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2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1226114"/>
                  </a:ext>
                </a:extLst>
              </a:tr>
              <a:tr h="22758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SH2B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7.4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9.3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.63</a:t>
                      </a:r>
                      <a:endParaRPr lang="en-GB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2.20, 3.1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1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57014470"/>
                  </a:ext>
                </a:extLst>
              </a:tr>
              <a:tr h="22758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TAPBP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250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944.2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.32</a:t>
                      </a:r>
                      <a:endParaRPr lang="en-GB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 1.10, 1.5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003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76385801"/>
                  </a:ext>
                </a:extLst>
              </a:tr>
            </a:tbl>
          </a:graphicData>
        </a:graphic>
      </p:graphicFrame>
      <p:sp>
        <p:nvSpPr>
          <p:cNvPr id="4" name="Google Shape;379;p10">
            <a:extLst>
              <a:ext uri="{FF2B5EF4-FFF2-40B4-BE49-F238E27FC236}">
                <a16:creationId xmlns:a16="http://schemas.microsoft.com/office/drawing/2014/main" id="{BCCDDD59-AB3C-4C10-A5B4-E799A7FFC1B2}"/>
              </a:ext>
            </a:extLst>
          </p:cNvPr>
          <p:cNvSpPr txBox="1"/>
          <p:nvPr/>
        </p:nvSpPr>
        <p:spPr>
          <a:xfrm>
            <a:off x="404282" y="7505432"/>
            <a:ext cx="6049433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Table 9: Genes differentially expressed in PBMCs from healthy control and arthralgia patients.</a:t>
            </a:r>
            <a:endParaRPr sz="12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6114731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BD4C4D2-7E25-44AE-9FC1-E9902BE354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344018"/>
              </p:ext>
            </p:extLst>
          </p:nvPr>
        </p:nvGraphicFramePr>
        <p:xfrm>
          <a:off x="657407" y="339858"/>
          <a:ext cx="5504207" cy="803930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1752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929637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949788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881010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  <a:gridCol w="881010">
                  <a:extLst>
                    <a:ext uri="{9D8B030D-6E8A-4147-A177-3AD203B41FA5}">
                      <a16:colId xmlns:a16="http://schemas.microsoft.com/office/drawing/2014/main" val="3198952295"/>
                    </a:ext>
                  </a:extLst>
                </a:gridCol>
                <a:gridCol w="881010">
                  <a:extLst>
                    <a:ext uri="{9D8B030D-6E8A-4147-A177-3AD203B41FA5}">
                      <a16:colId xmlns:a16="http://schemas.microsoft.com/office/drawing/2014/main" val="2756801190"/>
                    </a:ext>
                  </a:extLst>
                </a:gridCol>
              </a:tblGrid>
              <a:tr h="277952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/>
                        <a:t>Genes</a:t>
                      </a: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b="1" dirty="0"/>
                        <a:t>Mean Gene expression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3228766"/>
                  </a:ext>
                </a:extLst>
              </a:tr>
              <a:tr h="390739">
                <a:tc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 dirty="0"/>
                        <a:t>Healthy Contro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 dirty="0"/>
                        <a:t>Undifferentiated Arthrit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0442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G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35, -2.0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D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9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38, -3.6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32381871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 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1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71, -2.7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4741201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49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44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8, 2.1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0600811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6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087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94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46, -2.3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0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9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4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3.11, 4.9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18161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7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38, -3.7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1625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9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7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88, -2.9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16637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KLF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4.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2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51, -3.9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EC6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82, -2.8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1587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0.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3.9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15, -1.8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3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62, -2.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172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81, 4.4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X5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0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35, -3.7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1574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WSR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9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8.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7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93, - 4.6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15621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ER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2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36 , -2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  <a:tr h="1498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XP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62, - 2.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1226114"/>
                  </a:ext>
                </a:extLst>
              </a:tr>
              <a:tr h="17399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A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9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46, 2.2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57014470"/>
                  </a:ext>
                </a:extLst>
              </a:tr>
              <a:tr h="172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7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5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8, 2.1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76385801"/>
                  </a:ext>
                </a:extLst>
              </a:tr>
              <a:tr h="15621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LA-DQA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5.4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9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9.74, 15.3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66762502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LA-DQB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1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9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00, -1.5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73631552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B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2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6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7, 2.0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58267938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A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0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7, 2.16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829134831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I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8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3.5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5, 1.9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11130215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2RG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2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36, -2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0972678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4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6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7, 2.6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5193319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GA2B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0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59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5, 2.6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8021556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GA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6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39.2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3.96, 6.2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56867082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MP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1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6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43, 2.2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91318115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F2C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3.2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.0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86, -4.5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73548114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BNO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2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6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7, 2.00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386736894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B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3.07, 4.7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8501207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2B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09, -3.3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944263311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AD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9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30, -3.6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35810221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.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4.2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08, 1.7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72065130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K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09, 1.7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76561121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F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8, 2.1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2529235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B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0.99, -1.5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3829936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LR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5.5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07, 1.6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101394067"/>
                  </a:ext>
                </a:extLst>
              </a:tr>
              <a:tr h="22758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4.6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7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88, -2.9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561820390"/>
                  </a:ext>
                </a:extLst>
              </a:tr>
            </a:tbl>
          </a:graphicData>
        </a:graphic>
      </p:graphicFrame>
      <p:sp>
        <p:nvSpPr>
          <p:cNvPr id="4" name="Google Shape;379;p10">
            <a:extLst>
              <a:ext uri="{FF2B5EF4-FFF2-40B4-BE49-F238E27FC236}">
                <a16:creationId xmlns:a16="http://schemas.microsoft.com/office/drawing/2014/main" id="{BCCDDD59-AB3C-4C10-A5B4-E799A7FFC1B2}"/>
              </a:ext>
            </a:extLst>
          </p:cNvPr>
          <p:cNvSpPr txBox="1"/>
          <p:nvPr/>
        </p:nvSpPr>
        <p:spPr>
          <a:xfrm>
            <a:off x="384795" y="8478475"/>
            <a:ext cx="6049433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Table 10: Genes differentially expressed in PBMCs from healthy control and undifferentiated arthritis patients.</a:t>
            </a:r>
            <a:endParaRPr sz="12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76018835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BD4C4D2-7E25-44AE-9FC1-E9902BE354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374038"/>
              </p:ext>
            </p:extLst>
          </p:nvPr>
        </p:nvGraphicFramePr>
        <p:xfrm>
          <a:off x="676895" y="65865"/>
          <a:ext cx="5504208" cy="884837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1752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929637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949789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881010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  <a:gridCol w="1016517">
                  <a:extLst>
                    <a:ext uri="{9D8B030D-6E8A-4147-A177-3AD203B41FA5}">
                      <a16:colId xmlns:a16="http://schemas.microsoft.com/office/drawing/2014/main" val="3012265101"/>
                    </a:ext>
                  </a:extLst>
                </a:gridCol>
                <a:gridCol w="745503">
                  <a:extLst>
                    <a:ext uri="{9D8B030D-6E8A-4147-A177-3AD203B41FA5}">
                      <a16:colId xmlns:a16="http://schemas.microsoft.com/office/drawing/2014/main" val="2756801190"/>
                    </a:ext>
                  </a:extLst>
                </a:gridCol>
              </a:tblGrid>
              <a:tr h="306261">
                <a:tc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Healthy Contro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Early Arthrit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.5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6, -4.1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8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7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0.96, 1.5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32381871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CAM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9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53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2, 1.9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47412011"/>
                  </a:ext>
                </a:extLst>
              </a:tr>
              <a:tr h="18375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G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7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9.4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23, -3.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06008119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TF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.5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7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05, 1.6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L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4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63, -2.5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1824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I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9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3.6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6, 2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D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0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86, -4.5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7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2.8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0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55, -2.4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9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5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87, 2.9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R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5.4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63, -2.56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7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9.4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23, -3.5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7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9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04, 1.6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17737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9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6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01, - 3.1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0LG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08, - 1.69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0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92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6, 2.1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7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1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17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5, 2.60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122611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8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3.2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.8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9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52, -2.3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57014470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BPB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0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86, -4.5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76385801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D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5.5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22, 3.4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6676250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KLF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3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2, 2.55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7363155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EC4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0.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20, -3.4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5826793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EC6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4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66, -2.6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82913483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OT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3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97, -3.1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1113021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EB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6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17.6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41, 3.8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097267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S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9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54, -2.4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5193319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3.03, 4.7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8021556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5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17, -1.84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5686708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R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.9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9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0, 2.5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9131811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SP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1.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53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5, 1.9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73548114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K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8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4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81, 2.8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386736894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ER1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.4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4.24, -6.67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8501207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ER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08, -1.6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94426331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F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9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9.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 1.5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3581022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T3LG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7.7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12.8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57, 2.4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72065130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6PD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4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5.7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3.24, 5.0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7656112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A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0.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20, -3.4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8152965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7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9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6, 2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22271853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B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2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8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81, 2.8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48969726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A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6.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5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53, 2.4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2861533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2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9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4, 2.5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6019563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2RG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4.6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6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01 , -3.1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9740856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4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5.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0.8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43, 2.2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2529235"/>
                  </a:ext>
                </a:extLst>
              </a:tr>
              <a:tr h="19906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F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4.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2.8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19, 1.8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38299369"/>
                  </a:ext>
                </a:extLst>
              </a:tr>
              <a:tr h="18375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F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.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8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72, 2.7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101394067"/>
                  </a:ext>
                </a:extLst>
              </a:tr>
              <a:tr h="2286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F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8.8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6.8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62, -2.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561820390"/>
                  </a:ext>
                </a:extLst>
              </a:tr>
              <a:tr h="2286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8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4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81, 2.8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65205707"/>
                  </a:ext>
                </a:extLst>
              </a:tr>
            </a:tbl>
          </a:graphicData>
        </a:graphic>
      </p:graphicFrame>
      <p:sp>
        <p:nvSpPr>
          <p:cNvPr id="4" name="Google Shape;379;p10">
            <a:extLst>
              <a:ext uri="{FF2B5EF4-FFF2-40B4-BE49-F238E27FC236}">
                <a16:creationId xmlns:a16="http://schemas.microsoft.com/office/drawing/2014/main" id="{BCCDDD59-AB3C-4C10-A5B4-E799A7FFC1B2}"/>
              </a:ext>
            </a:extLst>
          </p:cNvPr>
          <p:cNvSpPr txBox="1"/>
          <p:nvPr/>
        </p:nvSpPr>
        <p:spPr>
          <a:xfrm>
            <a:off x="404282" y="8943114"/>
            <a:ext cx="6049433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1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Table 11: Genes differentially expressed in PBMCs from healthy control and Early arthritis patients.</a:t>
            </a:r>
            <a:endParaRPr sz="11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83879511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379;p10">
            <a:extLst>
              <a:ext uri="{FF2B5EF4-FFF2-40B4-BE49-F238E27FC236}">
                <a16:creationId xmlns:a16="http://schemas.microsoft.com/office/drawing/2014/main" id="{1392BA5C-FD59-4685-AC71-4592E55F1583}"/>
              </a:ext>
            </a:extLst>
          </p:cNvPr>
          <p:cNvSpPr txBox="1"/>
          <p:nvPr/>
        </p:nvSpPr>
        <p:spPr>
          <a:xfrm>
            <a:off x="404282" y="6244527"/>
            <a:ext cx="6049433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1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Table 11b: Genes differentially expressed in PBMCs from healthy control and Early arthritis patients.</a:t>
            </a:r>
            <a:endParaRPr sz="11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D5D71E4-84E7-4BAF-BC57-6F31855CE7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2116911"/>
              </p:ext>
            </p:extLst>
          </p:nvPr>
        </p:nvGraphicFramePr>
        <p:xfrm>
          <a:off x="676895" y="515182"/>
          <a:ext cx="5504208" cy="526293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1752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929637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949789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881010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  <a:gridCol w="1055742">
                  <a:extLst>
                    <a:ext uri="{9D8B030D-6E8A-4147-A177-3AD203B41FA5}">
                      <a16:colId xmlns:a16="http://schemas.microsoft.com/office/drawing/2014/main" val="1027439344"/>
                    </a:ext>
                  </a:extLst>
                </a:gridCol>
                <a:gridCol w="706278">
                  <a:extLst>
                    <a:ext uri="{9D8B030D-6E8A-4147-A177-3AD203B41FA5}">
                      <a16:colId xmlns:a16="http://schemas.microsoft.com/office/drawing/2014/main" val="2756801190"/>
                    </a:ext>
                  </a:extLst>
                </a:gridCol>
              </a:tblGrid>
              <a:tr h="306261">
                <a:tc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Healthy Contro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Early Arthrit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MP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1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5, 2.3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2K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9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4, 2.5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32381871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K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9.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3.1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5, 2.3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47412011"/>
                  </a:ext>
                </a:extLst>
              </a:tr>
              <a:tr h="18375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KAPK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1.1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8.5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11, 3.3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06008119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F2C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5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49, 2.3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FV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2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5.8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1, 2.0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1824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R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6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8.4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36, -2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KB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7.3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53, 2.4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CH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8.4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8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15, 1.8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I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4.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2.8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19, 1.8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D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2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5.16, 8.1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R</a:t>
                      </a:r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7.3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3, 2.1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BNO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8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7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0.96, 1.5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17737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B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88, 2.9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2B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18, -3.4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2D1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8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0.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10, 3.3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AMF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7.9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9 , 2.0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122611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AD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6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6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3.06 , 4.8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57014470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CS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7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.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 7.95, -12.4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76385801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7.6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3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09, 1.7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6676250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9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53, 2.4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73631552"/>
                  </a:ext>
                </a:extLst>
              </a:tr>
              <a:tr h="18375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K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08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94.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4.73, -7.4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101394067"/>
                  </a:ext>
                </a:extLst>
              </a:tr>
              <a:tr h="2286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F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5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.7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9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31, -3.6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561820390"/>
                  </a:ext>
                </a:extLst>
              </a:tr>
              <a:tr h="2286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</a:t>
                      </a:r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97,-3.2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65205707"/>
                  </a:ext>
                </a:extLst>
              </a:tr>
              <a:tr h="2286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AIP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9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38.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15, 1.8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4476835"/>
                  </a:ext>
                </a:extLst>
              </a:tr>
              <a:tr h="2286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3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15, 1.80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599952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0866409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79;p10">
            <a:extLst>
              <a:ext uri="{FF2B5EF4-FFF2-40B4-BE49-F238E27FC236}">
                <a16:creationId xmlns:a16="http://schemas.microsoft.com/office/drawing/2014/main" id="{FE9DE8B2-C7A1-40A1-87B4-7CF004444AA1}"/>
              </a:ext>
            </a:extLst>
          </p:cNvPr>
          <p:cNvSpPr txBox="1"/>
          <p:nvPr/>
        </p:nvSpPr>
        <p:spPr>
          <a:xfrm>
            <a:off x="478570" y="8647288"/>
            <a:ext cx="5900855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1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Table 12: Genes differentially expressed in PBMCs from healthy control and established RA</a:t>
            </a:r>
            <a:endParaRPr sz="11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5C54FB9-7466-48AF-8F18-F83E0C9DFD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3584671"/>
              </p:ext>
            </p:extLst>
          </p:nvPr>
        </p:nvGraphicFramePr>
        <p:xfrm>
          <a:off x="676894" y="65865"/>
          <a:ext cx="5504208" cy="85081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1752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929637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949789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881010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  <a:gridCol w="1032593">
                  <a:extLst>
                    <a:ext uri="{9D8B030D-6E8A-4147-A177-3AD203B41FA5}">
                      <a16:colId xmlns:a16="http://schemas.microsoft.com/office/drawing/2014/main" val="1917451555"/>
                    </a:ext>
                  </a:extLst>
                </a:gridCol>
                <a:gridCol w="729427">
                  <a:extLst>
                    <a:ext uri="{9D8B030D-6E8A-4147-A177-3AD203B41FA5}">
                      <a16:colId xmlns:a16="http://schemas.microsoft.com/office/drawing/2014/main" val="2756801190"/>
                    </a:ext>
                  </a:extLst>
                </a:gridCol>
              </a:tblGrid>
              <a:tr h="302678">
                <a:tc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Healthy Contro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Established Arthrit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CB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.1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3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3.03, 4.7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5.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1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5, 2.3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21854247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8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5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05, 1.6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3858023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CAM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51, 2.3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7514936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G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.5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6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48, -3.9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20331597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TF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9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56,2.4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32381871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L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4, 1.4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47412011"/>
                  </a:ext>
                </a:extLst>
              </a:tr>
              <a:tr h="18375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I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4.6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0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3,2.1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06008119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7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0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23,1.9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D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3.19, -5.0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1824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.4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17, 1.8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7.7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6.9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64, -2.6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4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2.0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7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4.54, 22.89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9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3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2, 2.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L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3.19, 5.0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ND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4.7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4.2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10, -3.3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R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7.3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5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9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52, -2.3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17737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R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9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3.16, -4.9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R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4.7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3.4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38, -2.7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6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4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64, -4.1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6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5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.7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89, -2.9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122611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C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0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3.14, -4.9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57014470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D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6.5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76,-2.7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76385801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24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8.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3.6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42,2.2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6676250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9.6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6, 2.1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7363155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5.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8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15, -1.8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5826793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.5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5.5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19,1.8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82913483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4.6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9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79, -2.8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1113021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0LG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2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4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6, 2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097267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5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1.6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59, 2.5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5193319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1.1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1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26, 3.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8021556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3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6.9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14,1.7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5686708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79B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9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9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06, 1.6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9131811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8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16,1.8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73548114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3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07, 3.2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8501207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BPB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5.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0.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46, 2.3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94426331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EC4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0.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1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25, -3.5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3581022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1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.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3.82, -6.0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72065130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EB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4.57,-7.2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7656112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SF3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1.8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8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2.24, -3.5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8152965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L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3.26, 5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22271853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R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8.8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06, 3.2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48969726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CR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71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89.6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03, 3.2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2861533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JC1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5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5,2.1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6019563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SP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.8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4.91,7.7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974085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652632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79;p10">
            <a:extLst>
              <a:ext uri="{FF2B5EF4-FFF2-40B4-BE49-F238E27FC236}">
                <a16:creationId xmlns:a16="http://schemas.microsoft.com/office/drawing/2014/main" id="{FE9DE8B2-C7A1-40A1-87B4-7CF004444AA1}"/>
              </a:ext>
            </a:extLst>
          </p:cNvPr>
          <p:cNvSpPr txBox="1"/>
          <p:nvPr/>
        </p:nvSpPr>
        <p:spPr>
          <a:xfrm>
            <a:off x="478571" y="8862711"/>
            <a:ext cx="5900855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1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Table 12b: Genes differentially expressed in PBMCs from healthy control and established RA</a:t>
            </a:r>
            <a:endParaRPr sz="11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5C54FB9-7466-48AF-8F18-F83E0C9DFD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5634787"/>
              </p:ext>
            </p:extLst>
          </p:nvPr>
        </p:nvGraphicFramePr>
        <p:xfrm>
          <a:off x="676895" y="65865"/>
          <a:ext cx="5972582" cy="86842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1752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929637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949789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881010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  <a:gridCol w="1489392">
                  <a:extLst>
                    <a:ext uri="{9D8B030D-6E8A-4147-A177-3AD203B41FA5}">
                      <a16:colId xmlns:a16="http://schemas.microsoft.com/office/drawing/2014/main" val="2073713416"/>
                    </a:ext>
                  </a:extLst>
                </a:gridCol>
                <a:gridCol w="741002">
                  <a:extLst>
                    <a:ext uri="{9D8B030D-6E8A-4147-A177-3AD203B41FA5}">
                      <a16:colId xmlns:a16="http://schemas.microsoft.com/office/drawing/2014/main" val="2756801190"/>
                    </a:ext>
                  </a:extLst>
                </a:gridCol>
              </a:tblGrid>
              <a:tr h="306261">
                <a:tc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Healthy Contro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Established Arthrit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S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17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53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07, 1.6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2RL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2, 2.0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21854247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ER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85, -2.9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3858023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GR2B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4.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2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67, 2.6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7514936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T3LG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4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9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3.34, 5.2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20331597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6PD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4.3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87, -2.9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32381871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A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4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67, 2.6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47412011"/>
                  </a:ext>
                </a:extLst>
              </a:tr>
              <a:tr h="18375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I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4.7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7.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08, -1.7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06008119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F3C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8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13,1.7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7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8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42, 2.2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1824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AC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0.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6, 2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B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2.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8.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3, 2.5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A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0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9, 2.6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2RB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.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7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 1.42, -2.2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3RA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7.6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6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2.23, -3.5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2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77, 2.7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7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17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85.3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43, 2.2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17737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F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1.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24.9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22 , 1.9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F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8.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24.9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5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22,-1.9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F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8.4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3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25, 1.9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F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9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.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68,2.6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122611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F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2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6.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15, 1.8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57014470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GA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6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5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1,2.0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76385801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GA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3.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7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01, -1.5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6676250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GB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76.8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9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99, -3.1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7363155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8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7.0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69, 2.6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5826793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LRG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2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6.1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0, 1.8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82913483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MP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0.5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4.5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4, -2.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1113021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CP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44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73.1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8, 2.0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097267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9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.9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3.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0.95, - 1.50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5193319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K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.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2.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79, 2.8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8021556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KAPK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6.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3.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2, 2.0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56867082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FV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.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3.57, -5.6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9131811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RPS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0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0.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0.92, - 1.4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73548114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KB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9.3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98, 3.1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386736894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CH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.9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9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01, 3.1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8501207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CAM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51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0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81, -2.8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94426331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I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4.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9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4, 1.9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3581022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D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7.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4.57, 7.2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72065130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KCE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15, 1.8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76561121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R</a:t>
                      </a:r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9.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8.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41, 2.2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8152965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BNO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.6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8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11, 1.7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22271853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B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34, 1.9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48969726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3A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9.9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3.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18, 1.8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28615335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2B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 2.34, -3.6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60195638"/>
                  </a:ext>
                </a:extLst>
              </a:tr>
              <a:tr h="1761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2D1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8.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28, 2.01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974085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3452560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79;p10">
            <a:extLst>
              <a:ext uri="{FF2B5EF4-FFF2-40B4-BE49-F238E27FC236}">
                <a16:creationId xmlns:a16="http://schemas.microsoft.com/office/drawing/2014/main" id="{FE9DE8B2-C7A1-40A1-87B4-7CF004444AA1}"/>
              </a:ext>
            </a:extLst>
          </p:cNvPr>
          <p:cNvSpPr txBox="1"/>
          <p:nvPr/>
        </p:nvSpPr>
        <p:spPr>
          <a:xfrm>
            <a:off x="478571" y="5298819"/>
            <a:ext cx="5900855" cy="4308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1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Table 12c: Genes differentially expressed in PBMCs from healthy control and established RA</a:t>
            </a:r>
            <a:endParaRPr sz="11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5C54FB9-7466-48AF-8F18-F83E0C9DFD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6270795"/>
              </p:ext>
            </p:extLst>
          </p:nvPr>
        </p:nvGraphicFramePr>
        <p:xfrm>
          <a:off x="676894" y="285784"/>
          <a:ext cx="5504208" cy="48100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1752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929637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949789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881010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  <a:gridCol w="1032593">
                  <a:extLst>
                    <a:ext uri="{9D8B030D-6E8A-4147-A177-3AD203B41FA5}">
                      <a16:colId xmlns:a16="http://schemas.microsoft.com/office/drawing/2014/main" val="1260748086"/>
                    </a:ext>
                  </a:extLst>
                </a:gridCol>
                <a:gridCol w="729427">
                  <a:extLst>
                    <a:ext uri="{9D8B030D-6E8A-4147-A177-3AD203B41FA5}">
                      <a16:colId xmlns:a16="http://schemas.microsoft.com/office/drawing/2014/main" val="2756801190"/>
                    </a:ext>
                  </a:extLst>
                </a:gridCol>
              </a:tblGrid>
              <a:tr h="306261">
                <a:tc>
                  <a:txBody>
                    <a:bodyPr/>
                    <a:lstStyle/>
                    <a:p>
                      <a:pPr algn="ctr"/>
                      <a:endParaRPr lang="en-GB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Healthy Contro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/>
                        <a:t>Established Arthrit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AMF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9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38, 2.1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AD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3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1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78, -2.8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21854247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CS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1.67,-2.6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3858023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.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1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68, 4.2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75149369"/>
                  </a:ext>
                </a:extLst>
              </a:tr>
              <a:tr h="20540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9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4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1.02 -1.6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20331597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F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6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7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12, 3.33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32381871"/>
                  </a:ext>
                </a:extLst>
              </a:tr>
              <a:tr h="19396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</a:t>
                      </a:r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01, -3.1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47412011"/>
                  </a:ext>
                </a:extLst>
              </a:tr>
              <a:tr h="18375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CAM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.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5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4, -2.5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06008119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AIP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0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88.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46,2.3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TE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2.65, 4.1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1824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.5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56,2.4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P7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3.5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46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18, 1.8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AMF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9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3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38, 2.1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AD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3.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1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78, -2.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CS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1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7, -2.6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17865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.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1.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68, 4.2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9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4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02, 1.6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17737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F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6.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7.2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12, 3.3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</a:t>
                      </a:r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.3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 -2.01, -3.1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CAM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.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5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4, -2.58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AIP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0.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88.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46, 2.3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1226114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TE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.65, 4.8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57014470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K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.5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56 , 2.4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76385801"/>
                  </a:ext>
                </a:extLst>
              </a:tr>
              <a:tr h="1748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P7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3.5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46.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.18, 1.87]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667625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0131224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2">
            <a:extLst>
              <a:ext uri="{FF2B5EF4-FFF2-40B4-BE49-F238E27FC236}">
                <a16:creationId xmlns:a16="http://schemas.microsoft.com/office/drawing/2014/main" id="{712090F0-2B02-4EFA-9A0C-2A86845FF0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7643906"/>
              </p:ext>
            </p:extLst>
          </p:nvPr>
        </p:nvGraphicFramePr>
        <p:xfrm>
          <a:off x="395890" y="563548"/>
          <a:ext cx="6085420" cy="420730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93576">
                  <a:extLst>
                    <a:ext uri="{9D8B030D-6E8A-4147-A177-3AD203B41FA5}">
                      <a16:colId xmlns:a16="http://schemas.microsoft.com/office/drawing/2014/main" val="3627992642"/>
                    </a:ext>
                  </a:extLst>
                </a:gridCol>
                <a:gridCol w="908136">
                  <a:extLst>
                    <a:ext uri="{9D8B030D-6E8A-4147-A177-3AD203B41FA5}">
                      <a16:colId xmlns:a16="http://schemas.microsoft.com/office/drawing/2014/main" val="1958894546"/>
                    </a:ext>
                  </a:extLst>
                </a:gridCol>
                <a:gridCol w="888598">
                  <a:extLst>
                    <a:ext uri="{9D8B030D-6E8A-4147-A177-3AD203B41FA5}">
                      <a16:colId xmlns:a16="http://schemas.microsoft.com/office/drawing/2014/main" val="2975377708"/>
                    </a:ext>
                  </a:extLst>
                </a:gridCol>
                <a:gridCol w="1138024">
                  <a:extLst>
                    <a:ext uri="{9D8B030D-6E8A-4147-A177-3AD203B41FA5}">
                      <a16:colId xmlns:a16="http://schemas.microsoft.com/office/drawing/2014/main" val="4257400082"/>
                    </a:ext>
                  </a:extLst>
                </a:gridCol>
                <a:gridCol w="904856">
                  <a:extLst>
                    <a:ext uri="{9D8B030D-6E8A-4147-A177-3AD203B41FA5}">
                      <a16:colId xmlns:a16="http://schemas.microsoft.com/office/drawing/2014/main" val="2490915605"/>
                    </a:ext>
                  </a:extLst>
                </a:gridCol>
                <a:gridCol w="552230">
                  <a:extLst>
                    <a:ext uri="{9D8B030D-6E8A-4147-A177-3AD203B41FA5}">
                      <a16:colId xmlns:a16="http://schemas.microsoft.com/office/drawing/2014/main" val="433658929"/>
                    </a:ext>
                  </a:extLst>
                </a:gridCol>
              </a:tblGrid>
              <a:tr h="777438">
                <a:tc>
                  <a:txBody>
                    <a:bodyPr/>
                    <a:lstStyle/>
                    <a:p>
                      <a:endParaRPr lang="en-GB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PA</a:t>
                      </a:r>
                      <a:r>
                        <a:rPr lang="en-GB" sz="9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GB" sz="9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</a:t>
                      </a: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thralgia patients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 1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PA</a:t>
                      </a:r>
                      <a:r>
                        <a:rPr lang="en-GB" sz="9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thralgia patients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7)</a:t>
                      </a:r>
                    </a:p>
                    <a:p>
                      <a:pPr algn="ctr"/>
                      <a:endParaRPr lang="en-GB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PA</a:t>
                      </a:r>
                      <a:r>
                        <a:rPr lang="en-GB" sz="9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GB" sz="9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</a:t>
                      </a: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thralgia patients that develop RA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5)</a:t>
                      </a:r>
                    </a:p>
                    <a:p>
                      <a:pPr algn="ctr"/>
                      <a:endParaRPr lang="en-GB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PA</a:t>
                      </a:r>
                      <a:r>
                        <a:rPr lang="en-GB" sz="9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thralgia patients that develop RA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275214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.44 ± 10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.32 ± 7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80 ± 8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12 ± 9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1379196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32 ± 13.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2 ± 14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69 ± 11.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32 ± 12.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5976974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63 ± 10.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3 ± 12.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8 ± 5.8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2 ±.8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852745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89 ± 14.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34 ± 12.5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01 ± 11.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53 ± 13.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4953282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69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5 ± 1.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8 ± 1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1 ± 2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2 ± 2.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084753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54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3 ± 8.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87 ± 4.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1 ± 8.8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1 ± 6.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2684182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s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 CD4 T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6 ± 2.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1 ± 2.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6 ± 2.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5 ± 2.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3042171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17 (% CD4 T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3 ± 1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1 ± 1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2 ± 2.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9  ± 2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976919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icular helper (% CD4 T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6 ± 0.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2 ± 0.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6 ± 1.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8  ± 0.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2800682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4 ± 6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0 ± 4.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8 ± 5.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9  ± 6.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404213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( 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98 ± 13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29 ± 20.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32 ± 11.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96  ± 7.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054275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switched memory  ( 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9 ± 8.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.55 ± 6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88 ± 14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17 ± 10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5022261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witched memory  ( 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47 ± 10.4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18 ± 18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10 ± 13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09 ± 11.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707290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7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D</a:t>
                      </a:r>
                      <a:r>
                        <a:rPr lang="en-GB" sz="8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7 ± 5.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2 ± 6.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2 ± 4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45 ± 4.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8284790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4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3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6 ± 1.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5 ± 1.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0 ± 1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3 ± 1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5670479"/>
                  </a:ext>
                </a:extLst>
              </a:tr>
            </a:tbl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1E15A3EA-4281-44F4-B196-E6EB14DD7A2F}"/>
              </a:ext>
            </a:extLst>
          </p:cNvPr>
          <p:cNvSpPr txBox="1"/>
          <p:nvPr/>
        </p:nvSpPr>
        <p:spPr>
          <a:xfrm>
            <a:off x="658205" y="4867969"/>
            <a:ext cx="6199795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3 . Accelerated Immunological Ageing in Arthralgia patients developing RA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100" b="1" dirty="0"/>
              <a:t> 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8430271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2">
            <a:extLst>
              <a:ext uri="{FF2B5EF4-FFF2-40B4-BE49-F238E27FC236}">
                <a16:creationId xmlns:a16="http://schemas.microsoft.com/office/drawing/2014/main" id="{712090F0-2B02-4EFA-9A0C-2A86845FF0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674996"/>
              </p:ext>
            </p:extLst>
          </p:nvPr>
        </p:nvGraphicFramePr>
        <p:xfrm>
          <a:off x="700690" y="665148"/>
          <a:ext cx="4982560" cy="443596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19203">
                  <a:extLst>
                    <a:ext uri="{9D8B030D-6E8A-4147-A177-3AD203B41FA5}">
                      <a16:colId xmlns:a16="http://schemas.microsoft.com/office/drawing/2014/main" val="3627992642"/>
                    </a:ext>
                  </a:extLst>
                </a:gridCol>
                <a:gridCol w="1226114">
                  <a:extLst>
                    <a:ext uri="{9D8B030D-6E8A-4147-A177-3AD203B41FA5}">
                      <a16:colId xmlns:a16="http://schemas.microsoft.com/office/drawing/2014/main" val="1958894546"/>
                    </a:ext>
                  </a:extLst>
                </a:gridCol>
                <a:gridCol w="1078835">
                  <a:extLst>
                    <a:ext uri="{9D8B030D-6E8A-4147-A177-3AD203B41FA5}">
                      <a16:colId xmlns:a16="http://schemas.microsoft.com/office/drawing/2014/main" val="2490915605"/>
                    </a:ext>
                  </a:extLst>
                </a:gridCol>
                <a:gridCol w="658408">
                  <a:extLst>
                    <a:ext uri="{9D8B030D-6E8A-4147-A177-3AD203B41FA5}">
                      <a16:colId xmlns:a16="http://schemas.microsoft.com/office/drawing/2014/main" val="433658929"/>
                    </a:ext>
                  </a:extLst>
                </a:gridCol>
              </a:tblGrid>
              <a:tr h="777438">
                <a:tc>
                  <a:txBody>
                    <a:bodyPr/>
                    <a:lstStyle/>
                    <a:p>
                      <a:endParaRPr lang="en-GB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ifferentiated Arthritis patients 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 3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ifferentiated Arthritis patients that develop RA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275214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62 ± 9.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75 ± 8.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1379196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08 ± 15.5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17 ± 13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5976974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88 ± 15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4 ± 6.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852745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14 ± 12.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38 ± 9.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4953282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69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9 ± 3.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4 ± 2.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084753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54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5 ± 7.7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4 ± 8.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2684182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s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 CD4 T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1 ± 1.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8 ± 2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3042171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17 (% CD4 T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6 ± 1.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  ± 1.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976919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icular helper (% CD4 T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3 ± 1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9  ± 0.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2800682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9 ± 5.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5  ± 6.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404213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( 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09 ± 10.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04  ± 8.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054275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switched memory  ( 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32 ± 9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8 ± 11.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5022261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witched memory  ( 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1 ± 11.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32 ± 10.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707290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7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D</a:t>
                      </a:r>
                      <a:r>
                        <a:rPr lang="en-GB" sz="8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7 ± 5.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6 ± 6.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8284790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4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3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6 ± 1.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3 ± 1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5670479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 ± 1.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6 ± 4.5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257433"/>
                  </a:ext>
                </a:extLst>
              </a:tr>
            </a:tbl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1E15A3EA-4281-44F4-B196-E6EB14DD7A2F}"/>
              </a:ext>
            </a:extLst>
          </p:cNvPr>
          <p:cNvSpPr txBox="1"/>
          <p:nvPr/>
        </p:nvSpPr>
        <p:spPr>
          <a:xfrm>
            <a:off x="580468" y="5167154"/>
            <a:ext cx="6199795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4 . Accelerated Immunological Ageing in Arthralgia patients developing RA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100" b="1" dirty="0"/>
              <a:t> 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57338534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B0370C06-84AF-4D20-AF0E-2D2B250603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1642860"/>
              </p:ext>
            </p:extLst>
          </p:nvPr>
        </p:nvGraphicFramePr>
        <p:xfrm>
          <a:off x="700690" y="728133"/>
          <a:ext cx="4982560" cy="466442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19203">
                  <a:extLst>
                    <a:ext uri="{9D8B030D-6E8A-4147-A177-3AD203B41FA5}">
                      <a16:colId xmlns:a16="http://schemas.microsoft.com/office/drawing/2014/main" val="3627992642"/>
                    </a:ext>
                  </a:extLst>
                </a:gridCol>
                <a:gridCol w="1226114">
                  <a:extLst>
                    <a:ext uri="{9D8B030D-6E8A-4147-A177-3AD203B41FA5}">
                      <a16:colId xmlns:a16="http://schemas.microsoft.com/office/drawing/2014/main" val="1958894546"/>
                    </a:ext>
                  </a:extLst>
                </a:gridCol>
                <a:gridCol w="1078835">
                  <a:extLst>
                    <a:ext uri="{9D8B030D-6E8A-4147-A177-3AD203B41FA5}">
                      <a16:colId xmlns:a16="http://schemas.microsoft.com/office/drawing/2014/main" val="2490915605"/>
                    </a:ext>
                  </a:extLst>
                </a:gridCol>
                <a:gridCol w="658408">
                  <a:extLst>
                    <a:ext uri="{9D8B030D-6E8A-4147-A177-3AD203B41FA5}">
                      <a16:colId xmlns:a16="http://schemas.microsoft.com/office/drawing/2014/main" val="433658929"/>
                    </a:ext>
                  </a:extLst>
                </a:gridCol>
              </a:tblGrid>
              <a:tr h="714453">
                <a:tc>
                  <a:txBody>
                    <a:bodyPr/>
                    <a:lstStyle/>
                    <a:p>
                      <a:endParaRPr lang="en-GB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RD Naive Rheumatoid Arthritis patients 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 2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DMARD treatment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eumatoid Arthritis patient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2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275214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54 ± 8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.21 ± 9.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1379196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41 ± 14.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76 ± 16.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5976974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38 ± 10.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35 ± 12.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852745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14 ± 11.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25 ± 12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4953282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RA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6 ± 11.8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2 ± 3.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526846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69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9 ± 2.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6 ± 2.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084753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54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2 ± 4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3 ± 6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2684182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57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6 ± 3.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2 ± 4.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0123386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s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 CD4 T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3 ± 1.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1 ± 2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3042171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17 (% CD4 T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 ± 1.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2 ± 1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976919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6 ± 4.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7  ± 5.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404213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29 ± 9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32  ± 7.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0542757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switched memory 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16 ± 6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69 ± 8.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5022261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witched memory  ( 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62 ± 10.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8 ± 7.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7072903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7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D</a:t>
                      </a:r>
                      <a:r>
                        <a:rPr lang="en-GB" sz="8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8 ± 6.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52 ± 5.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8284790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4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3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1 ± 2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5 ± 1.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5670479"/>
                  </a:ext>
                </a:extLst>
              </a:tr>
              <a:tr h="22865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B cell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6 ± 1.9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3 ± 2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25743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A32F32A-9612-4483-ACB2-5E3DD3EEDB90}"/>
              </a:ext>
            </a:extLst>
          </p:cNvPr>
          <p:cNvSpPr txBox="1"/>
          <p:nvPr/>
        </p:nvSpPr>
        <p:spPr>
          <a:xfrm>
            <a:off x="550835" y="5514287"/>
            <a:ext cx="61997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Table 15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Comparison of immunological ageing features  between DMARD naïve and 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235935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4B1B6068-4F87-4EBF-8165-A9795C2188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2632534"/>
              </p:ext>
            </p:extLst>
          </p:nvPr>
        </p:nvGraphicFramePr>
        <p:xfrm>
          <a:off x="88900" y="584275"/>
          <a:ext cx="6680200" cy="499143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17650">
                  <a:extLst>
                    <a:ext uri="{9D8B030D-6E8A-4147-A177-3AD203B41FA5}">
                      <a16:colId xmlns:a16="http://schemas.microsoft.com/office/drawing/2014/main" val="3627992642"/>
                    </a:ext>
                  </a:extLst>
                </a:gridCol>
                <a:gridCol w="895350">
                  <a:extLst>
                    <a:ext uri="{9D8B030D-6E8A-4147-A177-3AD203B41FA5}">
                      <a16:colId xmlns:a16="http://schemas.microsoft.com/office/drawing/2014/main" val="1958894546"/>
                    </a:ext>
                  </a:extLst>
                </a:gridCol>
                <a:gridCol w="920750">
                  <a:extLst>
                    <a:ext uri="{9D8B030D-6E8A-4147-A177-3AD203B41FA5}">
                      <a16:colId xmlns:a16="http://schemas.microsoft.com/office/drawing/2014/main" val="4257400082"/>
                    </a:ext>
                  </a:extLst>
                </a:gridCol>
                <a:gridCol w="971550">
                  <a:extLst>
                    <a:ext uri="{9D8B030D-6E8A-4147-A177-3AD203B41FA5}">
                      <a16:colId xmlns:a16="http://schemas.microsoft.com/office/drawing/2014/main" val="4163691446"/>
                    </a:ext>
                  </a:extLst>
                </a:gridCol>
                <a:gridCol w="928724">
                  <a:extLst>
                    <a:ext uri="{9D8B030D-6E8A-4147-A177-3AD203B41FA5}">
                      <a16:colId xmlns:a16="http://schemas.microsoft.com/office/drawing/2014/main" val="3501655613"/>
                    </a:ext>
                  </a:extLst>
                </a:gridCol>
                <a:gridCol w="925476">
                  <a:extLst>
                    <a:ext uri="{9D8B030D-6E8A-4147-A177-3AD203B41FA5}">
                      <a16:colId xmlns:a16="http://schemas.microsoft.com/office/drawing/2014/main" val="2248129648"/>
                    </a:ext>
                  </a:extLst>
                </a:gridCol>
                <a:gridCol w="520700">
                  <a:extLst>
                    <a:ext uri="{9D8B030D-6E8A-4147-A177-3AD203B41FA5}">
                      <a16:colId xmlns:a16="http://schemas.microsoft.com/office/drawing/2014/main" val="2490915605"/>
                    </a:ext>
                  </a:extLst>
                </a:gridCol>
              </a:tblGrid>
              <a:tr h="390608">
                <a:tc>
                  <a:txBody>
                    <a:bodyPr/>
                    <a:lstStyle/>
                    <a:p>
                      <a:endParaRPr lang="en-GB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 controls 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 6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algia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32)</a:t>
                      </a:r>
                    </a:p>
                    <a:p>
                      <a:pPr algn="ctr"/>
                      <a:endParaRPr lang="en-GB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ifferentiated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itis 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4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rly Rheumatoid Arthritis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23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ablished Rheumatoi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iti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56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27521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91 ± 10.9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55 ± 9.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83 ± 8.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08 ± 11.7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39 ± 14.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1379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T cell count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 ± 0.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 ± 0.7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 ±  0.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 ± 0.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 ± 0.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11369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08 ± 15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16 ± 12.9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83 ± 15.5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57 ± 13.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77 ± 15.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5976974"/>
                  </a:ext>
                </a:extLst>
              </a:tr>
              <a:tr h="240783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ive CD4 T cells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 (0.24 – 0.4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( 0.23 – 0.3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 ( 0.13 -0.3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 ( 0.12- 0.2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 (0.11- 0.2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9453474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6 ( 0.41 – 12.5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8 (4.05-8.6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 ( 2.28 – 12.0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5 ( 3.66 – 17.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4 (5.47 – 18.09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852745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 CD4 T cells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( 0.02 – 0.0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( 0.04- 0.1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( 0.03 – 0.1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( 0.03 – 0.1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 ( 0.04 – 0.1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1369727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7( 6.51- 19.9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50 (16.34- 38.8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5 (13.40-33.9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13 (19.12-35.0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6 (12.76 – 33.8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4953282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 CD4 T cell count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( 0.02 – 0.0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( 0.04- 0.1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 0.05 – 0.1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 ( 0.07 – 0.2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 ( 0.04 – 0.1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383074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RA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32 (9.26 -30.7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0 (2.1 – 6.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 ( 2.6 – 15.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9 (20.98 -38.1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27 (16.82 -44.8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9118424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RA CD4 T cell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( 0.05 – 0.1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( 0.02- 0.1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( 0.02 – 0.1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 ( 0.05 – 0.2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 0.04 – 0.1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1232648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memory CD4 T cell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52 ± 19.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27 ± 13.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51 ± 12.6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88 ± 19.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79 ± 17.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6139314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mory CD4 T cell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 ± 0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 ± 0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 ±  0.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 ± 0.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 ± 0.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0847533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69 expression (MFI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.5 ± 37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8.7 ± 42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.2 ± 33.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2.8 ± 72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1.9 ± 84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2684182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54 expression (MFI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0.8 ± 82.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3.7 ± 99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9.2 ± 90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4.7 ± 47.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2.6 ± 59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3042171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 (0.33 – 3.0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8 ( 1.84 – 6.6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6 (1.2 – 3.8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1 (3.2 – 15.6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3 ( 5.2 – 11.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9769197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.007- 0.01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(0.01 – 0.02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( 0.008- 0.02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(0.029 – 0.07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 (0.026 -0.07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8301901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57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 ( 1.9 – 5.1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2 ( 2.11 – 6.7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8 ( 2.5 – 9.6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23 ( 6.24 – 21.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8 ( 4.5 – 22.2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4042133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57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T cells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0.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5015353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57 expression (MFI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6.52 ± 53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8.27 ± 73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2.51 ± 55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6.21 ± 104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3.9 ± 78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42282235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57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4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± 0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± 0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446367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32F7E80-430A-4F2C-86FC-75348D370C5E}"/>
              </a:ext>
            </a:extLst>
          </p:cNvPr>
          <p:cNvSpPr txBox="1"/>
          <p:nvPr/>
        </p:nvSpPr>
        <p:spPr>
          <a:xfrm>
            <a:off x="88900" y="5743110"/>
            <a:ext cx="644476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CD4 T cell subset distribution</a:t>
            </a:r>
          </a:p>
          <a:p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100" b="1" dirty="0"/>
              <a:t> </a:t>
            </a:r>
            <a:r>
              <a:rPr lang="en-GB" sz="1100" dirty="0"/>
              <a:t>Data are mean ± standard error mean for normally distributed data and median ( IQR) for skewed distributions based on mean/SD &lt; 2.  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07751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4B1B6068-4F87-4EBF-8165-A9795C2188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2719208"/>
              </p:ext>
            </p:extLst>
          </p:nvPr>
        </p:nvGraphicFramePr>
        <p:xfrm>
          <a:off x="69851" y="598521"/>
          <a:ext cx="6788149" cy="477535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8099">
                  <a:extLst>
                    <a:ext uri="{9D8B030D-6E8A-4147-A177-3AD203B41FA5}">
                      <a16:colId xmlns:a16="http://schemas.microsoft.com/office/drawing/2014/main" val="3627992642"/>
                    </a:ext>
                  </a:extLst>
                </a:gridCol>
                <a:gridCol w="977900">
                  <a:extLst>
                    <a:ext uri="{9D8B030D-6E8A-4147-A177-3AD203B41FA5}">
                      <a16:colId xmlns:a16="http://schemas.microsoft.com/office/drawing/2014/main" val="1958894546"/>
                    </a:ext>
                  </a:extLst>
                </a:gridCol>
                <a:gridCol w="1009650">
                  <a:extLst>
                    <a:ext uri="{9D8B030D-6E8A-4147-A177-3AD203B41FA5}">
                      <a16:colId xmlns:a16="http://schemas.microsoft.com/office/drawing/2014/main" val="4257400082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4163691446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3501655613"/>
                    </a:ext>
                  </a:extLst>
                </a:gridCol>
                <a:gridCol w="971550">
                  <a:extLst>
                    <a:ext uri="{9D8B030D-6E8A-4147-A177-3AD203B41FA5}">
                      <a16:colId xmlns:a16="http://schemas.microsoft.com/office/drawing/2014/main" val="2248129648"/>
                    </a:ext>
                  </a:extLst>
                </a:gridCol>
                <a:gridCol w="501650">
                  <a:extLst>
                    <a:ext uri="{9D8B030D-6E8A-4147-A177-3AD203B41FA5}">
                      <a16:colId xmlns:a16="http://schemas.microsoft.com/office/drawing/2014/main" val="2490915605"/>
                    </a:ext>
                  </a:extLst>
                </a:gridCol>
              </a:tblGrid>
              <a:tr h="390608">
                <a:tc>
                  <a:txBody>
                    <a:bodyPr/>
                    <a:lstStyle/>
                    <a:p>
                      <a:endParaRPr lang="en-GB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 controls 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 6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algia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32)</a:t>
                      </a:r>
                    </a:p>
                    <a:p>
                      <a:pPr algn="ctr"/>
                      <a:endParaRPr lang="en-GB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ifferentiated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itis 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4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rly Rheumatoid Arthritis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23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ablished Rheumatoi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iti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56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27521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12 ± 8.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17 ± 9.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91 ± 11.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08 ± 11.7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19 ± 13.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1379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T cell co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 ± 0.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 ± 0.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 ±  0.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 ± 0.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 ± 0.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11369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CD8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67 ± 15.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12 ± 18.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95 ± 19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45 ± 12.4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63 ± 13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5976974"/>
                  </a:ext>
                </a:extLst>
              </a:tr>
              <a:tr h="240783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ive CD8 T cell co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± 0.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 ± 0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 ±  0.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± 0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± 0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9453474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 CD8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 55 ( 4.7 – 16.6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7 ( 4.16 – 17.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 ( 5.18 – 12.7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80 (9.6 – 31.2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28 (16.33 -27.4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852745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 CD8 T cell co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( 0.03 – 0.0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( 0.04- 0.1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( 0.03 – 0.1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( 0.04 – 0.1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( 0.04 – 0.1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1369727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 CD8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4 ( 4.6 -13.9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 21 ( 3.8 – 11.7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6 (2.91- 14.4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68 ( 3.2 – 16.8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89 ( 3.77 – 17.8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4953282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 CD8 T cell co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( 0.04 – 0.1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( 0.03 – 0.1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( 0.04 – 0.1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(0.04 – 0.1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( 0.03 -0.1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383074"/>
                  </a:ext>
                </a:extLst>
              </a:tr>
              <a:tr h="139636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RA CD8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14 ± 11.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89 ± 14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2 ± 12.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09 ± 12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89 ± 11.7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9118424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RA CD8 T cell co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( 0 .03 – 0.2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( 0.03 – 0.1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( 0.04 – 0.1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( 0.04 – 0.1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( 0.03 – 0.0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1232648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mory CD8 T cell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87± 12.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97± 13.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05 ± 11.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54± 9.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.89± 12.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6139314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mory CD8 T cell co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 ± 0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 ± 0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 ±  0.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 ± 0.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 ± 0.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0847533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69 expression (MFI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2.6 ± 53.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3.2 ± 63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8.2 ± 54.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1.3 ± 61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8.4 ± 72.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5945070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54 expression (MFI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5.2 ± 32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1.6 ± 37.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9.2 ± 90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2.9 ± 64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3.7 ± 50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4473453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8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8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 (5.3 -13.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6 (4.02 -12.2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 ( 4.7 – 14.0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2 ( 14.4 – 25.1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13 ( 18.8 – 35.6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2802859"/>
                  </a:ext>
                </a:extLst>
              </a:tr>
              <a:tr h="221983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8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8 T cells (10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 0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± 0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5426639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57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8 T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1 ( 2.11 – 6.8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 ( 2.5 – 9.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38 ( 6.7 – 1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2 ( 14.1 – 25.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13 ( 14.1 – 25.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0405581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57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8 T cells (10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± 0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67274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57 expression (MFI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6.84 ± 77.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1.42 ± 91.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2.71 ± 44.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6.21 ± 98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8.61 ± 65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6989831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8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57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ve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8 (10</a:t>
                      </a:r>
                      <a:r>
                        <a:rPr lang="en-GB" sz="7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0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178447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32F7E80-430A-4F2C-86FC-75348D370C5E}"/>
              </a:ext>
            </a:extLst>
          </p:cNvPr>
          <p:cNvSpPr txBox="1"/>
          <p:nvPr/>
        </p:nvSpPr>
        <p:spPr>
          <a:xfrm>
            <a:off x="0" y="5725195"/>
            <a:ext cx="644476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. CD8 T cell subset distribution</a:t>
            </a:r>
          </a:p>
          <a:p>
            <a:r>
              <a:rPr lang="en-GB" sz="1200" b="1" dirty="0"/>
              <a:t> </a:t>
            </a:r>
            <a:r>
              <a:rPr lang="en-GB" sz="1200" dirty="0"/>
              <a:t>Data are mean ± standard error mean for normally distributed data and median ( IQR) for skewed distributions based on mean/SD &lt; 2.  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086971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BD4C4D2-7E25-44AE-9FC1-E9902BE354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9556263"/>
              </p:ext>
            </p:extLst>
          </p:nvPr>
        </p:nvGraphicFramePr>
        <p:xfrm>
          <a:off x="676895" y="619424"/>
          <a:ext cx="5504208" cy="372360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44105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1111250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1425916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722937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</a:tblGrid>
              <a:tr h="390739">
                <a:tc>
                  <a:txBody>
                    <a:bodyPr/>
                    <a:lstStyle/>
                    <a:p>
                      <a:r>
                        <a:rPr lang="en-GB" sz="1400" b="1" dirty="0"/>
                        <a:t>Variabl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35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efficient</a:t>
                      </a:r>
                    </a:p>
                    <a:p>
                      <a:pPr algn="ctr"/>
                      <a:r>
                        <a:rPr lang="en-GB" sz="1400" b="1" dirty="0"/>
                        <a:t>Estim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_male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1.222, 1.323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24740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BMI (kg/m</a:t>
                      </a:r>
                      <a:r>
                        <a:rPr lang="en-GB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011, 0.00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280673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uration (weeks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003, 0.005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_Positiv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[- 0.073, 0.065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P_Positiv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5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44, 0.04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Asian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125, 0.207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2852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Black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094, 0.378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White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ritish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050, 0.262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245521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us_Curren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259, 0.329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29273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status_ Ev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260, 0.328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status _Nev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311, 0.255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275708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isease severity score_DAS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 0.074, 0.118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</a:tbl>
          </a:graphicData>
        </a:graphic>
      </p:graphicFrame>
      <p:sp>
        <p:nvSpPr>
          <p:cNvPr id="3" name="TextBox 3">
            <a:extLst>
              <a:ext uri="{FF2B5EF4-FFF2-40B4-BE49-F238E27FC236}">
                <a16:creationId xmlns:a16="http://schemas.microsoft.com/office/drawing/2014/main" id="{5DBEF982-12F3-4AB5-857D-AE49F6AD6022}"/>
              </a:ext>
            </a:extLst>
          </p:cNvPr>
          <p:cNvSpPr txBox="1"/>
          <p:nvPr/>
        </p:nvSpPr>
        <p:spPr>
          <a:xfrm>
            <a:off x="437335" y="4720732"/>
            <a:ext cx="60806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. Multiple Linear Regressions of IMM-AGE score with participant demographics and clinical parameters in Arthralgia patients. </a:t>
            </a:r>
          </a:p>
        </p:txBody>
      </p:sp>
    </p:spTree>
    <p:extLst>
      <p:ext uri="{BB962C8B-B14F-4D97-AF65-F5344CB8AC3E}">
        <p14:creationId xmlns:p14="http://schemas.microsoft.com/office/powerpoint/2010/main" val="26263528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BD4C4D2-7E25-44AE-9FC1-E9902BE354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255963"/>
              </p:ext>
            </p:extLst>
          </p:nvPr>
        </p:nvGraphicFramePr>
        <p:xfrm>
          <a:off x="676895" y="590548"/>
          <a:ext cx="5504208" cy="394979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13955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1104900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1362416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722937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</a:tblGrid>
              <a:tr h="390739">
                <a:tc>
                  <a:txBody>
                    <a:bodyPr/>
                    <a:lstStyle/>
                    <a:p>
                      <a:r>
                        <a:rPr lang="en-GB" sz="1400" b="1" dirty="0"/>
                        <a:t>Variabl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efficient</a:t>
                      </a:r>
                    </a:p>
                    <a:p>
                      <a:pPr algn="ctr"/>
                      <a:r>
                        <a:rPr lang="en-GB" sz="1400" b="1" dirty="0"/>
                        <a:t>Estim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001, 0.00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_male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143, 0.6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24740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BMI (kg/m</a:t>
                      </a:r>
                      <a:r>
                        <a:rPr lang="en-GB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[-0.010, 0.00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280673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uration (weeks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5E-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002, 0.00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_Positiv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061, 0.32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P_Positiv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01, 0.35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Asian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20, 0.44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2852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Black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29, 0.16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White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ritish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74, 0.08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245521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us_Curren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74, 0.080]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29273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status_ Ev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9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336, 0.144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status _Nev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9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337, 0.14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227582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isease severity score_DAS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21, 0.10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</a:tbl>
          </a:graphicData>
        </a:graphic>
      </p:graphicFrame>
      <p:sp>
        <p:nvSpPr>
          <p:cNvPr id="3" name="TextBox 3">
            <a:extLst>
              <a:ext uri="{FF2B5EF4-FFF2-40B4-BE49-F238E27FC236}">
                <a16:creationId xmlns:a16="http://schemas.microsoft.com/office/drawing/2014/main" id="{5DBEF982-12F3-4AB5-857D-AE49F6AD6022}"/>
              </a:ext>
            </a:extLst>
          </p:cNvPr>
          <p:cNvSpPr txBox="1"/>
          <p:nvPr/>
        </p:nvSpPr>
        <p:spPr>
          <a:xfrm>
            <a:off x="388652" y="4850224"/>
            <a:ext cx="60806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. Multiple Linear Regressions of IMM-AGE score with participant demographics and clinical parameters in Undifferentiated Arthritis patients. </a:t>
            </a:r>
          </a:p>
        </p:txBody>
      </p:sp>
    </p:spTree>
    <p:extLst>
      <p:ext uri="{BB962C8B-B14F-4D97-AF65-F5344CB8AC3E}">
        <p14:creationId xmlns:p14="http://schemas.microsoft.com/office/powerpoint/2010/main" val="13710796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BD4C4D2-7E25-44AE-9FC1-E9902BE354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5218366"/>
              </p:ext>
            </p:extLst>
          </p:nvPr>
        </p:nvGraphicFramePr>
        <p:xfrm>
          <a:off x="676895" y="590548"/>
          <a:ext cx="5504208" cy="394979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52055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1003300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1549400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599453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</a:tblGrid>
              <a:tr h="390739">
                <a:tc>
                  <a:txBody>
                    <a:bodyPr/>
                    <a:lstStyle/>
                    <a:p>
                      <a:r>
                        <a:rPr lang="en-GB" sz="1400" b="1" dirty="0"/>
                        <a:t>Variabl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efficient</a:t>
                      </a:r>
                    </a:p>
                    <a:p>
                      <a:pPr algn="ctr"/>
                      <a:r>
                        <a:rPr lang="en-GB" sz="1400" b="1" dirty="0"/>
                        <a:t>Estim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 year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013, 0.00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_male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110, 0.27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24740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BMI (kg/m</a:t>
                      </a:r>
                      <a:r>
                        <a:rPr lang="en-GB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[-0.036, -0.00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280673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uration (weeks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010, 0.02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_Positiv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19, 0.14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P_Positiv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059, 0.24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Asian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008, 0.86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2852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Black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435, 0.22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White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ritish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078, 0.21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245521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us_Curren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29273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status_ Ev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101, 0.55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status _Nev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089, 0.525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227582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isease severity score_DAS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-0.136, 0.30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</a:tbl>
          </a:graphicData>
        </a:graphic>
      </p:graphicFrame>
      <p:sp>
        <p:nvSpPr>
          <p:cNvPr id="3" name="TextBox 3">
            <a:extLst>
              <a:ext uri="{FF2B5EF4-FFF2-40B4-BE49-F238E27FC236}">
                <a16:creationId xmlns:a16="http://schemas.microsoft.com/office/drawing/2014/main" id="{5DBEF982-12F3-4AB5-857D-AE49F6AD6022}"/>
              </a:ext>
            </a:extLst>
          </p:cNvPr>
          <p:cNvSpPr txBox="1"/>
          <p:nvPr/>
        </p:nvSpPr>
        <p:spPr>
          <a:xfrm>
            <a:off x="388651" y="4782392"/>
            <a:ext cx="60806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5. Multiple Linear Regressions of IMM-AGE score with participant demographics and clinical parameters in Early Arthritis patients. </a:t>
            </a:r>
          </a:p>
        </p:txBody>
      </p:sp>
    </p:spTree>
    <p:extLst>
      <p:ext uri="{BB962C8B-B14F-4D97-AF65-F5344CB8AC3E}">
        <p14:creationId xmlns:p14="http://schemas.microsoft.com/office/powerpoint/2010/main" val="39745963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BD4C4D2-7E25-44AE-9FC1-E9902BE354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1823589"/>
              </p:ext>
            </p:extLst>
          </p:nvPr>
        </p:nvGraphicFramePr>
        <p:xfrm>
          <a:off x="676895" y="590548"/>
          <a:ext cx="5504208" cy="394979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64755">
                  <a:extLst>
                    <a:ext uri="{9D8B030D-6E8A-4147-A177-3AD203B41FA5}">
                      <a16:colId xmlns:a16="http://schemas.microsoft.com/office/drawing/2014/main" val="2056275609"/>
                    </a:ext>
                  </a:extLst>
                </a:gridCol>
                <a:gridCol w="984250">
                  <a:extLst>
                    <a:ext uri="{9D8B030D-6E8A-4147-A177-3AD203B41FA5}">
                      <a16:colId xmlns:a16="http://schemas.microsoft.com/office/drawing/2014/main" val="210494512"/>
                    </a:ext>
                  </a:extLst>
                </a:gridCol>
                <a:gridCol w="1485900">
                  <a:extLst>
                    <a:ext uri="{9D8B030D-6E8A-4147-A177-3AD203B41FA5}">
                      <a16:colId xmlns:a16="http://schemas.microsoft.com/office/drawing/2014/main" val="3669376300"/>
                    </a:ext>
                  </a:extLst>
                </a:gridCol>
                <a:gridCol w="669303">
                  <a:extLst>
                    <a:ext uri="{9D8B030D-6E8A-4147-A177-3AD203B41FA5}">
                      <a16:colId xmlns:a16="http://schemas.microsoft.com/office/drawing/2014/main" val="4240637629"/>
                    </a:ext>
                  </a:extLst>
                </a:gridCol>
              </a:tblGrid>
              <a:tr h="390739">
                <a:tc>
                  <a:txBody>
                    <a:bodyPr/>
                    <a:lstStyle/>
                    <a:p>
                      <a:r>
                        <a:rPr lang="en-GB" sz="1400" b="1" dirty="0"/>
                        <a:t>Variabl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efficient</a:t>
                      </a:r>
                    </a:p>
                    <a:p>
                      <a:pPr algn="ctr"/>
                      <a:r>
                        <a:rPr lang="en-GB" sz="1400" b="1" dirty="0"/>
                        <a:t>Estim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95% 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7086982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012, 0.000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60029469"/>
                  </a:ext>
                </a:extLst>
              </a:tr>
              <a:tr h="269130">
                <a:tc>
                  <a:txBody>
                    <a:bodyPr/>
                    <a:lstStyle/>
                    <a:p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_male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042, 0.09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848873"/>
                  </a:ext>
                </a:extLst>
              </a:tr>
              <a:tr h="24740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BMI (kg/m</a:t>
                      </a:r>
                      <a:r>
                        <a:rPr lang="en-GB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 0.009, 0.003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7489693"/>
                  </a:ext>
                </a:extLst>
              </a:tr>
              <a:tr h="280673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uration (weeks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3E-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 0.0002 , 0.0002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21327748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_Positiv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071, 0.06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35998673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P_Positiv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171, -0.007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3719184"/>
                  </a:ext>
                </a:extLst>
              </a:tr>
              <a:tr h="2646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Asian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140, 0.236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17962378"/>
                  </a:ext>
                </a:extLst>
              </a:tr>
              <a:tr h="28523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Black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45309051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_Whit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189, 0.109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58668894"/>
                  </a:ext>
                </a:extLst>
              </a:tr>
              <a:tr h="245521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us_Curren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0454157"/>
                  </a:ext>
                </a:extLst>
              </a:tr>
              <a:tr h="29273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status_ Ev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107, 0.08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6718759"/>
                  </a:ext>
                </a:extLst>
              </a:tr>
              <a:tr h="25496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Smoking status _Nev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7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167, 0.021]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76826072"/>
                  </a:ext>
                </a:extLst>
              </a:tr>
              <a:tr h="227582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isease severity score_DAS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 -0.063, 0.097]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1106276"/>
                  </a:ext>
                </a:extLst>
              </a:tr>
            </a:tbl>
          </a:graphicData>
        </a:graphic>
      </p:graphicFrame>
      <p:sp>
        <p:nvSpPr>
          <p:cNvPr id="3" name="TextBox 3">
            <a:extLst>
              <a:ext uri="{FF2B5EF4-FFF2-40B4-BE49-F238E27FC236}">
                <a16:creationId xmlns:a16="http://schemas.microsoft.com/office/drawing/2014/main" id="{5DBEF982-12F3-4AB5-857D-AE49F6AD6022}"/>
              </a:ext>
            </a:extLst>
          </p:cNvPr>
          <p:cNvSpPr txBox="1"/>
          <p:nvPr/>
        </p:nvSpPr>
        <p:spPr>
          <a:xfrm>
            <a:off x="388651" y="4889500"/>
            <a:ext cx="60806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6. Multiple Linear Regressions of IMM-AGE score with participant demographics and clinical parameters in Established Arthritis patients. </a:t>
            </a:r>
          </a:p>
        </p:txBody>
      </p:sp>
    </p:spTree>
    <p:extLst>
      <p:ext uri="{BB962C8B-B14F-4D97-AF65-F5344CB8AC3E}">
        <p14:creationId xmlns:p14="http://schemas.microsoft.com/office/powerpoint/2010/main" val="42569250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4B1B6068-4F87-4EBF-8165-A9795C2188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3767454"/>
              </p:ext>
            </p:extLst>
          </p:nvPr>
        </p:nvGraphicFramePr>
        <p:xfrm>
          <a:off x="133350" y="217521"/>
          <a:ext cx="6591299" cy="293826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84350">
                  <a:extLst>
                    <a:ext uri="{9D8B030D-6E8A-4147-A177-3AD203B41FA5}">
                      <a16:colId xmlns:a16="http://schemas.microsoft.com/office/drawing/2014/main" val="3627992642"/>
                    </a:ext>
                  </a:extLst>
                </a:gridCol>
                <a:gridCol w="817033">
                  <a:extLst>
                    <a:ext uri="{9D8B030D-6E8A-4147-A177-3AD203B41FA5}">
                      <a16:colId xmlns:a16="http://schemas.microsoft.com/office/drawing/2014/main" val="1958894546"/>
                    </a:ext>
                  </a:extLst>
                </a:gridCol>
                <a:gridCol w="780627">
                  <a:extLst>
                    <a:ext uri="{9D8B030D-6E8A-4147-A177-3AD203B41FA5}">
                      <a16:colId xmlns:a16="http://schemas.microsoft.com/office/drawing/2014/main" val="4257400082"/>
                    </a:ext>
                  </a:extLst>
                </a:gridCol>
                <a:gridCol w="1010920">
                  <a:extLst>
                    <a:ext uri="{9D8B030D-6E8A-4147-A177-3AD203B41FA5}">
                      <a16:colId xmlns:a16="http://schemas.microsoft.com/office/drawing/2014/main" val="4163691446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3501655613"/>
                    </a:ext>
                  </a:extLst>
                </a:gridCol>
                <a:gridCol w="797560">
                  <a:extLst>
                    <a:ext uri="{9D8B030D-6E8A-4147-A177-3AD203B41FA5}">
                      <a16:colId xmlns:a16="http://schemas.microsoft.com/office/drawing/2014/main" val="2248129648"/>
                    </a:ext>
                  </a:extLst>
                </a:gridCol>
                <a:gridCol w="588009">
                  <a:extLst>
                    <a:ext uri="{9D8B030D-6E8A-4147-A177-3AD203B41FA5}">
                      <a16:colId xmlns:a16="http://schemas.microsoft.com/office/drawing/2014/main" val="2490915605"/>
                    </a:ext>
                  </a:extLst>
                </a:gridCol>
              </a:tblGrid>
              <a:tr h="390608">
                <a:tc>
                  <a:txBody>
                    <a:bodyPr/>
                    <a:lstStyle/>
                    <a:p>
                      <a:endParaRPr lang="en-GB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 controls 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 6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algia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32)</a:t>
                      </a:r>
                    </a:p>
                    <a:p>
                      <a:pPr algn="ctr"/>
                      <a:endParaRPr lang="en-GB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ifferentiated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itis 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4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rly Rheumatoid Arthritis</a:t>
                      </a:r>
                    </a:p>
                    <a:p>
                      <a:pPr algn="ctr"/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23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ablished Rheumatoi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hriti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 n = 56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27521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44 ± 2.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5 ± 6.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1 ± 6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5 ± 6.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2 ± 6.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1379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cell count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 ± 0.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 ± 0.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 ±  0.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 ± 0.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 ± 0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1136906"/>
                  </a:ext>
                </a:extLst>
              </a:tr>
              <a:tr h="240783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ïve B cell count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± 0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± 0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± 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0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9453474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switched Memory B cells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44 ± 2.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5 ± 6.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1 ± 6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5 ± 6.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2 ± 6.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852745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switched Memory B cells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± 0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± 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± 0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1369727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witched Memory B cells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± 0.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 ± 0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±  0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 ± 0.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 ± 0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4953282"/>
                  </a:ext>
                </a:extLst>
              </a:tr>
              <a:tr h="22470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D</a:t>
                      </a:r>
                      <a:r>
                        <a:rPr lang="en-GB" sz="8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27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e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 cells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± 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± 0.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383074"/>
                  </a:ext>
                </a:extLst>
              </a:tr>
              <a:tr h="139636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ulatory B cells 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0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9118424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8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 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0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1232648"/>
                  </a:ext>
                </a:extLst>
              </a:tr>
              <a:tr h="15671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-associated B cells 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</a:t>
                      </a:r>
                      <a:r>
                        <a:rPr lang="en-GB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± 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± 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613931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E60939A-9A6A-4106-A84F-007319C5DDD8}"/>
              </a:ext>
            </a:extLst>
          </p:cNvPr>
          <p:cNvSpPr txBox="1"/>
          <p:nvPr/>
        </p:nvSpPr>
        <p:spPr>
          <a:xfrm>
            <a:off x="279887" y="3295261"/>
            <a:ext cx="64447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7. B cell subset distribution </a:t>
            </a:r>
          </a:p>
        </p:txBody>
      </p:sp>
    </p:spTree>
    <p:extLst>
      <p:ext uri="{BB962C8B-B14F-4D97-AF65-F5344CB8AC3E}">
        <p14:creationId xmlns:p14="http://schemas.microsoft.com/office/powerpoint/2010/main" val="40367115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783BED4-A345-4F86-B908-1347283262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0374508"/>
              </p:ext>
            </p:extLst>
          </p:nvPr>
        </p:nvGraphicFramePr>
        <p:xfrm>
          <a:off x="311943" y="1170980"/>
          <a:ext cx="6234113" cy="3962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71549">
                  <a:extLst>
                    <a:ext uri="{9D8B030D-6E8A-4147-A177-3AD203B41FA5}">
                      <a16:colId xmlns:a16="http://schemas.microsoft.com/office/drawing/2014/main" val="4061366835"/>
                    </a:ext>
                  </a:extLst>
                </a:gridCol>
                <a:gridCol w="863600">
                  <a:extLst>
                    <a:ext uri="{9D8B030D-6E8A-4147-A177-3AD203B41FA5}">
                      <a16:colId xmlns:a16="http://schemas.microsoft.com/office/drawing/2014/main" val="2791589822"/>
                    </a:ext>
                  </a:extLst>
                </a:gridCol>
                <a:gridCol w="831850">
                  <a:extLst>
                    <a:ext uri="{9D8B030D-6E8A-4147-A177-3AD203B41FA5}">
                      <a16:colId xmlns:a16="http://schemas.microsoft.com/office/drawing/2014/main" val="598151615"/>
                    </a:ext>
                  </a:extLst>
                </a:gridCol>
                <a:gridCol w="950624">
                  <a:extLst>
                    <a:ext uri="{9D8B030D-6E8A-4147-A177-3AD203B41FA5}">
                      <a16:colId xmlns:a16="http://schemas.microsoft.com/office/drawing/2014/main" val="830633501"/>
                    </a:ext>
                  </a:extLst>
                </a:gridCol>
                <a:gridCol w="967279">
                  <a:extLst>
                    <a:ext uri="{9D8B030D-6E8A-4147-A177-3AD203B41FA5}">
                      <a16:colId xmlns:a16="http://schemas.microsoft.com/office/drawing/2014/main" val="2898912290"/>
                    </a:ext>
                  </a:extLst>
                </a:gridCol>
                <a:gridCol w="986625">
                  <a:extLst>
                    <a:ext uri="{9D8B030D-6E8A-4147-A177-3AD203B41FA5}">
                      <a16:colId xmlns:a16="http://schemas.microsoft.com/office/drawing/2014/main" val="3641393950"/>
                    </a:ext>
                  </a:extLst>
                </a:gridCol>
                <a:gridCol w="662586">
                  <a:extLst>
                    <a:ext uri="{9D8B030D-6E8A-4147-A177-3AD203B41FA5}">
                      <a16:colId xmlns:a16="http://schemas.microsoft.com/office/drawing/2014/main" val="3861252846"/>
                    </a:ext>
                  </a:extLst>
                </a:gridCol>
              </a:tblGrid>
              <a:tr h="72179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GB" sz="1050" b="1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>
                          <a:effectLst/>
                        </a:rPr>
                        <a:t>Healthy controls </a:t>
                      </a:r>
                      <a:endParaRPr lang="en-GB" sz="1050" b="1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>
                          <a:effectLst/>
                        </a:rPr>
                        <a:t>(n = 43)</a:t>
                      </a:r>
                      <a:endParaRPr lang="en-GB" sz="10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>
                          <a:effectLst/>
                        </a:rPr>
                        <a:t>Arthralgia</a:t>
                      </a:r>
                      <a:endParaRPr lang="en-GB" sz="1050" b="1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>
                          <a:effectLst/>
                        </a:rPr>
                        <a:t>(n = 22)</a:t>
                      </a:r>
                      <a:endParaRPr lang="en-GB" sz="10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>
                          <a:effectLst/>
                        </a:rPr>
                        <a:t>UA</a:t>
                      </a:r>
                      <a:endParaRPr lang="en-GB" sz="1050" b="1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>
                          <a:effectLst/>
                        </a:rPr>
                        <a:t>(n = 22)</a:t>
                      </a:r>
                      <a:endParaRPr lang="en-GB" sz="10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>
                          <a:effectLst/>
                        </a:rPr>
                        <a:t>Early RA</a:t>
                      </a:r>
                      <a:endParaRPr lang="en-GB" sz="1050" b="1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>
                          <a:effectLst/>
                        </a:rPr>
                        <a:t>(n = 15)</a:t>
                      </a:r>
                      <a:endParaRPr lang="en-GB" sz="10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 dirty="0">
                          <a:effectLst/>
                        </a:rPr>
                        <a:t>Established RA</a:t>
                      </a:r>
                    </a:p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 dirty="0">
                          <a:effectLst/>
                        </a:rPr>
                        <a:t> (n =29) 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b="1" dirty="0">
                          <a:effectLst/>
                        </a:rPr>
                        <a:t>P value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1725209089"/>
                  </a:ext>
                </a:extLst>
              </a:tr>
              <a:tr h="3057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IL1ß 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0.74 ± 0.6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7.87 ± 6.3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6.07 ± 4.7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9.72 ± 5.4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4.69 ± 11.0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0.0011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2374554410"/>
                  </a:ext>
                </a:extLst>
              </a:tr>
              <a:tr h="31063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IL4 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2.34 ± 0.4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.98 ± 0.9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3.4 ± 1.0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.96 ± 0.4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2.11 ± 1.2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0.4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2753407567"/>
                  </a:ext>
                </a:extLst>
              </a:tr>
              <a:tr h="29868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IL6 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.88 ± 1.6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5.28 ± 5.9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0.54 ± 6.4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4.96 ± 0.2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22.11 ± 19.2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0.032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879947850"/>
                  </a:ext>
                </a:extLst>
              </a:tr>
              <a:tr h="31661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IL7 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7.66 ± 3.6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9.09 ± 5.2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8.37 ± 5.9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8.39 ± 5.2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6.42 ± 5.4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0.54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1063084760"/>
                  </a:ext>
                </a:extLst>
              </a:tr>
              <a:tr h="31661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IL10 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3.51 ± 1.9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4.39 ± 2.8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5.25 ± 2.1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9.57 ± 6.1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8.45 ±5.5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0.042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2468331048"/>
                  </a:ext>
                </a:extLst>
              </a:tr>
              <a:tr h="304663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IL17 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 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.31 ± 0.6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3.52 ± 3.4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5.24 ± 3.3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0.77 ± 8.8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6.51 ±11.2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0.0009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2594937854"/>
                  </a:ext>
                </a:extLst>
              </a:tr>
              <a:tr h="31661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TNFα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3.54 ± 1.2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8.91 ± 7.6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8.6 ± 7.0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6.42 ± 17.0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34.24 ± 22.3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0.0003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499026958"/>
                  </a:ext>
                </a:extLst>
              </a:tr>
              <a:tr h="280767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CRP (</a:t>
                      </a:r>
                      <a:r>
                        <a:rPr lang="en-US" sz="1000" b="1" dirty="0" err="1">
                          <a:effectLst/>
                        </a:rPr>
                        <a:t>μ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.20 ± 0.5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9.69 ± 4.5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0.59 ± 11.9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21.17 ± 19.2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23.57 ± 15.7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 0.0002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2507198569"/>
                  </a:ext>
                </a:extLst>
              </a:tr>
              <a:tr h="31661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 err="1">
                          <a:effectLst/>
                        </a:rPr>
                        <a:t>IFNγ</a:t>
                      </a:r>
                      <a:r>
                        <a:rPr lang="en-US" sz="1000" b="1" dirty="0">
                          <a:effectLst/>
                        </a:rPr>
                        <a:t> 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>
                          <a:effectLst/>
                        </a:rPr>
                        <a:t>145.7 ± 48.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900">
                          <a:effectLst/>
                        </a:rPr>
                        <a:t>186.6 ± 86.0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71.05</a:t>
                      </a:r>
                      <a:r>
                        <a:rPr lang="en-US" sz="900">
                          <a:effectLst/>
                        </a:rPr>
                        <a:t> ± 93.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16" marR="5716" marT="5716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231.2</a:t>
                      </a:r>
                      <a:r>
                        <a:rPr lang="en-US" sz="900">
                          <a:effectLst/>
                        </a:rPr>
                        <a:t> ± 53.2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189.53</a:t>
                      </a:r>
                      <a:r>
                        <a:rPr lang="en-US" sz="900">
                          <a:effectLst/>
                        </a:rPr>
                        <a:t> ± 75.5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0.67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2960407201"/>
                  </a:ext>
                </a:extLst>
              </a:tr>
              <a:tr h="444607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dirty="0">
                          <a:effectLst/>
                        </a:rPr>
                        <a:t>CXCL9(</a:t>
                      </a:r>
                      <a:r>
                        <a:rPr lang="en-US" sz="1000" b="1" dirty="0" err="1">
                          <a:effectLst/>
                        </a:rPr>
                        <a:t>pg</a:t>
                      </a:r>
                      <a:r>
                        <a:rPr lang="en-US" sz="1000" b="1" dirty="0">
                          <a:effectLst/>
                        </a:rPr>
                        <a:t>/ml)</a:t>
                      </a:r>
                      <a:endParaRPr lang="en-GB" sz="10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2704 ± 150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3252 ± 259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3992 ± 161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4875 ± 203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>
                          <a:effectLst/>
                        </a:rPr>
                        <a:t>4556 ± 308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900" dirty="0">
                          <a:effectLst/>
                        </a:rPr>
                        <a:t>0.041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312" marR="82312" marT="41156" marB="41156"/>
                </a:tc>
                <a:extLst>
                  <a:ext uri="{0D108BD9-81ED-4DB2-BD59-A6C34878D82A}">
                    <a16:rowId xmlns:a16="http://schemas.microsoft.com/office/drawing/2014/main" val="3107431178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AF42E868-DC96-4276-BE89-F353E2C311C8}"/>
              </a:ext>
            </a:extLst>
          </p:cNvPr>
          <p:cNvSpPr/>
          <p:nvPr/>
        </p:nvSpPr>
        <p:spPr>
          <a:xfrm>
            <a:off x="395185" y="5496456"/>
            <a:ext cx="6067628" cy="9903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8 Serum cytokine levels 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500"/>
              </a:spcBef>
              <a:spcAft>
                <a:spcPts val="500"/>
              </a:spcAft>
            </a:pP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Data are mean ± standard deviation. One-way ANOVA with Bonferroni’s multiple comparison test. Abbreviations: CRP, C reactive protein; TNF,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umor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necrosis factor; IFN, interferons; IL, interleukins</a:t>
            </a:r>
          </a:p>
        </p:txBody>
      </p:sp>
    </p:spTree>
    <p:extLst>
      <p:ext uri="{BB962C8B-B14F-4D97-AF65-F5344CB8AC3E}">
        <p14:creationId xmlns:p14="http://schemas.microsoft.com/office/powerpoint/2010/main" val="2650571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317</TotalTime>
  <Words>6368</Words>
  <Application>Microsoft Office PowerPoint</Application>
  <PresentationFormat>On-screen Show (4:3)</PresentationFormat>
  <Paragraphs>2491</Paragraphs>
  <Slides>1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9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Office Theme</vt:lpstr>
      <vt:lpstr>Prism 5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h Duggal</dc:creator>
  <cp:lastModifiedBy>Niharika Duggal (Inflammation and Ageing)</cp:lastModifiedBy>
  <cp:revision>1573</cp:revision>
  <dcterms:created xsi:type="dcterms:W3CDTF">2019-05-11T13:55:56Z</dcterms:created>
  <dcterms:modified xsi:type="dcterms:W3CDTF">2025-09-01T10:34:54Z</dcterms:modified>
</cp:coreProperties>
</file>